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94646"/>
  </p:normalViewPr>
  <p:slideViewPr>
    <p:cSldViewPr snapToGrid="0" snapToObjects="1">
      <p:cViewPr varScale="1">
        <p:scale>
          <a:sx n="101" d="100"/>
          <a:sy n="101" d="100"/>
        </p:scale>
        <p:origin x="23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C06CB2-C518-A847-8B9B-94EA83F0BB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45198AE-5C6B-5D43-A459-3FD7192E34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FD8BD7-5FAF-8F4B-8653-366C2F9B9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BA4DFAD-9CC4-E246-9599-0A10CFBD1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B107CD-2820-684A-8DB7-6FC9701FD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4004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A87C5C-5328-7F43-95E6-B0783E0D0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8681745-C8B2-0B41-9B23-FE0F2375DE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2BF492-C2F0-9545-985F-EE8B44F2F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9968EC2-F389-FE47-9053-C9D0D9D4F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B02F46-6D3C-6F4D-B80D-6EC2482E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738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70C77C7-AB25-AF40-9D08-9F1B05D0DF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776A35E-D1EE-A54F-87B2-2DDB64B251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398BFF7-6F4C-AB40-8B12-4D1A5EC1A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B5DE510-5F0D-F44B-8DFB-82E8C362E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0C07B7-6642-394E-8C95-42B12EE6E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0655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CDD5B8-729E-1145-AB74-10852E60E2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E733528-B47C-3C4E-B5CA-10EEE1D292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0B6502-33D7-464F-9313-AFCB09C37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7178FAD-A866-3C48-AA5B-FAC869B2D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70E821D-A0D8-D848-959B-BB5A72359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0114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B0D98DF-9855-EF46-A261-3FC2FB934B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2AED2F9-4DF8-D94E-9D74-8EF16BB6B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6DFD97-AB2D-9F4D-B824-B13220012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D07F5F-E2BC-CC4F-A57B-3C61CCC2D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AA9C479-7423-E547-AA87-63B9079AA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3267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BF1F9D-FD4F-B741-AD3E-F770334291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6BBA56F-C22B-4440-9EE1-27040AD6F4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4CB93B4-F509-AC44-AA2D-3FC05B395C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3284F23-D4D0-E44D-98B8-79A45638A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2F633C7-A372-C645-8880-1BCC29A65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3F974B1-080D-2C45-806A-B2A280DC3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142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4CC9A4-A258-0444-B555-F0FB6F9D0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C54282-7642-604E-9885-069D84C7E5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A4C004E-06D1-6542-A07E-12E5E74965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9E27D8F-3D7E-464D-A4E1-B7D04E905B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8031278-C03F-7C40-B9B7-CFB0603814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0CC780A-83EE-C942-8C6E-9DA327E6D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AA87351-8972-4142-AE68-FAB8F768A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D4C3E46-6496-AD4C-9D72-4553784D4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325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B9498F-3F45-464D-BF19-E0E0030697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86B3DD8-9F5F-974A-A2B1-071E86DFA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3075595-3E32-FB40-A241-4EE09019D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ED34605-0D34-8441-8AFC-E1578BBE2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8060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D88064D-08A9-0746-BDEF-140DC3F3F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52CF73A-6FC9-E04A-8DC9-999202E03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F066CB54-66DD-3445-BD9F-AEC10BBDD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771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04E168-E015-314F-9A97-F33781FCB1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5C88F22-E794-954B-BC4E-A87BE966CB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7792BA5-365D-374E-91B6-C9A39FF4E7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E4A48E7-862A-6843-B657-1F8D4C66B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971F6D4-2FEA-F94E-A2E8-737E19F04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CE653C4-79DE-8E47-8049-644B2CA50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1533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104DF7-3BAE-734E-9AE4-F80A04A3E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6D5E46A-0820-E84B-9412-8977168F13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3447891-742A-B94C-9068-78F2D4299E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B70105C-5FA1-A24F-88CA-CF675349B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A99C017-5F9F-9E40-BE58-52691BBE6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F439075-F9DE-6847-86ED-E9C55242C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446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BE5DBDE-915D-4845-93EB-4E5A7F024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AA483BF-5353-3649-9303-04C832B386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0DA0264-A48D-9A4D-A96C-03F7B1864E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AB5A3-1DED-6A4C-B372-7DBF381DDDF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F8AA504-C725-734E-9CCD-70D14F4639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FF565A9-9F23-D242-82D5-FFA85B088D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9ED6A-79EB-294F-AC99-D63C62C0D0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7013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1E63BB68-6421-5F4A-8A37-2314201302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83180" y="2232326"/>
            <a:ext cx="5443133" cy="4123774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5921CFDD-B7D3-2E45-8CA5-E4F0A8102B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422850" y="2232326"/>
            <a:ext cx="5453828" cy="4123774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90A8E91E-746F-D341-8B03-3F292FA636EB}"/>
              </a:ext>
            </a:extLst>
          </p:cNvPr>
          <p:cNvSpPr txBox="1"/>
          <p:nvPr/>
        </p:nvSpPr>
        <p:spPr>
          <a:xfrm>
            <a:off x="883180" y="1859281"/>
            <a:ext cx="544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+/+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6AE2DD5-1739-574D-A3B8-B6E500F92801}"/>
              </a:ext>
            </a:extLst>
          </p:cNvPr>
          <p:cNvSpPr txBox="1"/>
          <p:nvPr/>
        </p:nvSpPr>
        <p:spPr>
          <a:xfrm>
            <a:off x="6433545" y="1859281"/>
            <a:ext cx="544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D5688744-2E60-B744-B771-C238F3345746}"/>
              </a:ext>
            </a:extLst>
          </p:cNvPr>
          <p:cNvSpPr txBox="1"/>
          <p:nvPr/>
        </p:nvSpPr>
        <p:spPr>
          <a:xfrm>
            <a:off x="883180" y="6356100"/>
            <a:ext cx="17969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 = 30µm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FB847E6-D752-6147-9C6F-7951EAF3B598}"/>
              </a:ext>
            </a:extLst>
          </p:cNvPr>
          <p:cNvSpPr txBox="1"/>
          <p:nvPr/>
        </p:nvSpPr>
        <p:spPr>
          <a:xfrm>
            <a:off x="0" y="15103"/>
            <a:ext cx="12192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leads to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lteration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body composition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G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istologi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ver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 (ORO) for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droplets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66993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5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yana abboud</dc:creator>
  <cp:lastModifiedBy>Utilisateur Microsoft Office</cp:lastModifiedBy>
  <cp:revision>4</cp:revision>
  <dcterms:created xsi:type="dcterms:W3CDTF">2019-04-05T11:38:58Z</dcterms:created>
  <dcterms:modified xsi:type="dcterms:W3CDTF">2020-05-25T17:56:56Z</dcterms:modified>
</cp:coreProperties>
</file>